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3673"/>
  </p:normalViewPr>
  <p:slideViewPr>
    <p:cSldViewPr snapToGrid="0" snapToObjects="1">
      <p:cViewPr>
        <p:scale>
          <a:sx n="63" d="100"/>
          <a:sy n="63" d="100"/>
        </p:scale>
        <p:origin x="1744" y="9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173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582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007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501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92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06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444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99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582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83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277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8A7CC-4137-F44F-9998-D6922E6142E9}" type="datetimeFigureOut">
              <a:rPr lang="en-US" smtClean="0"/>
              <a:t>3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0B1DA-6236-6E42-BD03-205F1E211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530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7-12-27 at 10.03.54 PM.png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37" t="22564" r="25555" b="10539"/>
          <a:stretch/>
        </p:blipFill>
        <p:spPr>
          <a:xfrm>
            <a:off x="846528" y="530506"/>
            <a:ext cx="2779776" cy="2410060"/>
          </a:xfrm>
          <a:prstGeom prst="rect">
            <a:avLst/>
          </a:prstGeom>
        </p:spPr>
      </p:pic>
      <p:pic>
        <p:nvPicPr>
          <p:cNvPr id="5" name="Picture 4" descr="Screen Shot 2017-12-27 at 10.19.36 PM.pn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81" t="23846" r="26466" b="10537"/>
          <a:stretch/>
        </p:blipFill>
        <p:spPr>
          <a:xfrm>
            <a:off x="4678053" y="553012"/>
            <a:ext cx="2779776" cy="241006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67651" y="120180"/>
            <a:ext cx="1314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nt heigh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610641" y="101646"/>
            <a:ext cx="154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lk diameter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93761" y="3710566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ind thicknes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602330" y="3697866"/>
            <a:ext cx="24191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ascular bundle density</a:t>
            </a:r>
          </a:p>
        </p:txBody>
      </p:sp>
      <p:pic>
        <p:nvPicPr>
          <p:cNvPr id="11" name="Picture 10" descr="Screen Shot 2017-12-27 at 10.41.31 PM.png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7" t="19333" r="26484" b="10444"/>
          <a:stretch/>
        </p:blipFill>
        <p:spPr>
          <a:xfrm>
            <a:off x="3003121" y="4064000"/>
            <a:ext cx="2779776" cy="2414016"/>
          </a:xfrm>
          <a:prstGeom prst="rect">
            <a:avLst/>
          </a:prstGeom>
        </p:spPr>
      </p:pic>
      <p:pic>
        <p:nvPicPr>
          <p:cNvPr id="12" name="Picture 11" descr="Screen Shot 2017-12-27 at 10.22.47 PM.png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44" t="22889" r="29271" b="10000"/>
          <a:stretch/>
        </p:blipFill>
        <p:spPr>
          <a:xfrm>
            <a:off x="19242" y="4114800"/>
            <a:ext cx="2779776" cy="2414016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7AF7A0F6-6E64-CB4D-8925-F3382F579D0E}"/>
              </a:ext>
            </a:extLst>
          </p:cNvPr>
          <p:cNvGrpSpPr/>
          <p:nvPr/>
        </p:nvGrpSpPr>
        <p:grpSpPr>
          <a:xfrm>
            <a:off x="6187101" y="3704026"/>
            <a:ext cx="2779776" cy="2708656"/>
            <a:chOff x="6009301" y="3329264"/>
            <a:chExt cx="3119697" cy="3468576"/>
          </a:xfrm>
        </p:grpSpPr>
        <p:sp>
          <p:nvSpPr>
            <p:cNvPr id="10" name="TextBox 9"/>
            <p:cNvSpPr txBox="1"/>
            <p:nvPr/>
          </p:nvSpPr>
          <p:spPr>
            <a:xfrm>
              <a:off x="6798489" y="3329264"/>
              <a:ext cx="21531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Vascular bundle area</a:t>
              </a:r>
            </a:p>
          </p:txBody>
        </p:sp>
        <p:pic>
          <p:nvPicPr>
            <p:cNvPr id="2" name="Picture 1" descr="Screen Shot 2017-12-27 at 11.00.28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62" t="22000" r="26484" b="16838"/>
            <a:stretch/>
          </p:blipFill>
          <p:spPr>
            <a:xfrm>
              <a:off x="6009301" y="4066672"/>
              <a:ext cx="3119697" cy="2550696"/>
            </a:xfrm>
            <a:prstGeom prst="rect">
              <a:avLst/>
            </a:prstGeom>
          </p:spPr>
        </p:pic>
        <p:pic>
          <p:nvPicPr>
            <p:cNvPr id="13" name="Picture 12" descr="Screen Shot 2017-12-27 at 10.41.31 PM.png">
              <a:extLst>
                <a:ext uri="{FF2B5EF4-FFF2-40B4-BE49-F238E27FC236}">
                  <a16:creationId xmlns:a16="http://schemas.microsoft.com/office/drawing/2014/main" id="{3BCD1F8A-3BBC-CF46-AA1C-12E7C00908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83" t="82696" r="33562" b="11144"/>
            <a:stretch/>
          </p:blipFill>
          <p:spPr>
            <a:xfrm>
              <a:off x="7156069" y="6557209"/>
              <a:ext cx="1515980" cy="2406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68232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12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 User</dc:creator>
  <cp:lastModifiedBy>Mona Mazaheri</cp:lastModifiedBy>
  <cp:revision>9</cp:revision>
  <dcterms:created xsi:type="dcterms:W3CDTF">2017-12-28T04:01:41Z</dcterms:created>
  <dcterms:modified xsi:type="dcterms:W3CDTF">2018-03-10T18:05:37Z</dcterms:modified>
</cp:coreProperties>
</file>